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112" y="-2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755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16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067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623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691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253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141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2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478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853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426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BC1DA7-507E-8549-A375-19CFA3427FB5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D0357-0168-0D4B-876B-C1A36CA84C8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93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2485042"/>
              </p:ext>
            </p:extLst>
          </p:nvPr>
        </p:nvGraphicFramePr>
        <p:xfrm>
          <a:off x="357561" y="1193035"/>
          <a:ext cx="8575834" cy="4452750"/>
        </p:xfrm>
        <a:graphic>
          <a:graphicData uri="http://schemas.openxmlformats.org/drawingml/2006/table">
            <a:tbl>
              <a:tblPr/>
              <a:tblGrid>
                <a:gridCol w="1342019"/>
                <a:gridCol w="709198"/>
                <a:gridCol w="829215"/>
                <a:gridCol w="654644"/>
                <a:gridCol w="665555"/>
                <a:gridCol w="665555"/>
                <a:gridCol w="654644"/>
                <a:gridCol w="643734"/>
                <a:gridCol w="676465"/>
                <a:gridCol w="763751"/>
                <a:gridCol w="971054"/>
              </a:tblGrid>
              <a:tr h="1612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oup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 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 Spo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 Spots 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 Spo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ulverized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61242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hu-HU" sz="11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pc42-10</a:t>
                      </a:r>
                      <a:r>
                        <a:rPr lang="hu-HU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se4-GFP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0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t-IT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30min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1Hr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3Hr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2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oup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 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 Spo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 Spots 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 Spots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 Spot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ulverized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61242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cs-CZ" sz="11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pc42-10</a:t>
                      </a:r>
                      <a:r>
                        <a:rPr lang="cs-CZ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Ndc10-GFP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0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t-IT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30min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1Hr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4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hr-H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 3Hr</a:t>
                      </a:r>
                    </a:p>
                  </a:txBody>
                  <a:tcPr marL="10470" marR="10470" marT="1047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6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7</a:t>
                      </a:r>
                    </a:p>
                  </a:txBody>
                  <a:tcPr marL="10470" marR="10470" marT="104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46593" y="885258"/>
            <a:ext cx="41174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8 Table Data summary table for figure S1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99736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0</Words>
  <Application>Microsoft Macintosh PowerPoint</Application>
  <PresentationFormat>On-screen Show (4:3)</PresentationFormat>
  <Paragraphs>2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se Wester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Tartakoff</dc:creator>
  <cp:lastModifiedBy>Alan Tartakoff</cp:lastModifiedBy>
  <cp:revision>2</cp:revision>
  <dcterms:created xsi:type="dcterms:W3CDTF">2017-03-10T17:56:30Z</dcterms:created>
  <dcterms:modified xsi:type="dcterms:W3CDTF">2017-03-10T17:58:02Z</dcterms:modified>
</cp:coreProperties>
</file>